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Default Extension="jpg" ContentType="image/jpg"/>
  <Default Extension="svg" ContentType="image/svg+xml"/>
  <Default Extension="png" ContentType="image/png"/>
  <Default Extension="gif" ContentType="image/gif"/>
  <Default Extension="m4v" ContentType="video/mp4"/>
  <Default Extension="mp4" ContentType="video/mp4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Masters/slideMaster2.xml" ContentType="application/vnd.openxmlformats-officedocument.presentationml.slideMaster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1-1.xml" ContentType="application/vnd.openxmlformats-officedocument.presentationml.tags+xml"/>
  <Override PartName="/ppt/tags/tag1-2.xml" ContentType="application/vnd.openxmlformats-officedocument.presentationml.tags+xml"/>
  <Override PartName="/ppt/tags/tag1-3.xml" ContentType="application/vnd.openxmlformats-officedocument.presentationml.tags+xml"/>
  <Override PartName="/ppt/tags/tag1-4.xml" ContentType="application/vnd.openxmlformats-officedocument.presentationml.tags+xml"/>
  <Override PartName="/ppt/tags/tag1-5.xml" ContentType="application/vnd.openxmlformats-officedocument.presentationml.tags+xml"/>
  <Override PartName="/ppt/tags/tag1-6.xml" ContentType="application/vnd.openxmlformats-officedocument.presentationml.tags+xml"/>
  <Override PartName="/ppt/tags/tag1-7.xml" ContentType="application/vnd.openxmlformats-officedocument.presentationml.tags+xml"/>
  <Override PartName="/ppt/tags/tag1-8.xml" ContentType="application/vnd.openxmlformats-officedocument.presentationml.tags+xml"/>
  <Override PartName="/ppt/tags/tag1-9.xml" ContentType="application/vnd.openxmlformats-officedocument.presentationml.tags+xml"/>
  <Override PartName="/ppt/tags/tag1-10.xml" ContentType="application/vnd.openxmlformats-officedocument.presentationml.tags+xml"/>
  <Override PartName="/ppt/tags/tag1-11.xml" ContentType="application/vnd.openxmlformats-officedocument.presentationml.tags+xml"/>
  <Override PartName="/ppt/tags/tag1-12.xml" ContentType="application/vnd.openxmlformats-officedocument.presentationml.tags+xml"/>
  <Override PartName="/ppt/tags/tag1-1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
		<Relationship Id="rId1" Type="http://schemas.openxmlformats.org/officeDocument/2006/relationships/extended-properties" Target="docProps/app.xml"/>
		<Relationship Id="rId2" Type="http://schemas.openxmlformats.org/package/2006/relationships/metadata/core-properties" Target="docProps/core.xml"/>
		<Relationship Id="rId3" Type="http://schemas.openxmlformats.org/officeDocument/2006/relationships/officeDocument" Target="ppt/presentation.xml"/>
		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notesMasterIdLst>
    <p:notesMasterId r:id="rId4"/>
  </p:notesMasterIdLst>
  <p:sldSz cx="9144000" cy="6400800"/>
  <p:notesSz cx="64008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10"/>
  </p:normalViewPr>
  <p:slideViewPr>
    <p:cSldViewPr snapToGrid="0" snapToObjects="1">
      <p:cViewPr varScale="1">
        <p:scale>
          <a:sx n="136" d="100"/>
          <a:sy n="136" d="100"/>
        </p:scale>
        <p:origin x="21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
		<Relationship Id="rId1" Type="http://schemas.openxmlformats.org/officeDocument/2006/relationships/theme" Target="../theme/theme1.xml"/>
		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82F153-3F37-0F45-9E97-73ACFA13230C}" type="datetimeFigureOut">
              <a:rPr lang="en-US"/>
              <a:t>7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5E9CC1-C706-0F49-92D6-E571CC5EEA8F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
		<Relationships xmlns="http://schemas.openxmlformats.org/package/2006/relationships">
			<Relationship Id="rId1" Type="http://schemas.openxmlformats.org/officeDocument/2006/relationships/notesMaster" Target="../notesMasters/notesMaster1.xml"/>
			<Relationship Id="rId2" Type="http://schemas.openxmlformats.org/officeDocument/2006/relationships/slide" Target="../slides/slide1.xml"/>
		</Relationships>
</file>

<file path=ppt/notesSlides/_rels/notesSlide2.xml.rels><?xml version="1.0" encoding="UTF-8" standalone="yes"?>
		<Relationships xmlns="http://schemas.openxmlformats.org/package/2006/relationships">
			<Relationship Id="rId1" Type="http://schemas.openxmlformats.org/officeDocument/2006/relationships/notesMaster" Target="../notesMasters/notesMaster1.xml"/>
			<Relationship Id="rId2" Type="http://schemas.openxmlformats.org/officeDocument/2006/relationships/slide" Target="../slides/slide2.xml"/>
		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tags" Target="../tags/tag1-1.xml"/><Relationship Id="rId3" Type="http://schemas.openxmlformats.org/officeDocument/2006/relationships/tags" Target="../tags/tag1-2.xml"/><Relationship Id="rId5" Type="http://schemas.openxmlformats.org/officeDocument/2006/relationships/tags" Target="../tags/tag1-3.xml"/><Relationship Id="rId7" Type="http://schemas.openxmlformats.org/officeDocument/2006/relationships/tags" Target="../tags/tag1-4.xml"/><Relationship Id="rId9" Type="http://schemas.openxmlformats.org/officeDocument/2006/relationships/tags" Target="../tags/tag1-5.xml"/><Relationship Id="rId11" Type="http://schemas.openxmlformats.org/officeDocument/2006/relationships/tags" Target="../tags/tag1-6.xml"/><Relationship Id="rId13" Type="http://schemas.openxmlformats.org/officeDocument/2006/relationships/tags" Target="../tags/tag1-7.xml"/><Relationship Id="rId15" Type="http://schemas.openxmlformats.org/officeDocument/2006/relationships/tags" Target="../tags/tag1-8.xml"/><Relationship Id="rId17" Type="http://schemas.openxmlformats.org/officeDocument/2006/relationships/tags" Target="../tags/tag1-9.xml"/><Relationship Id="rId19" Type="http://schemas.openxmlformats.org/officeDocument/2006/relationships/tags" Target="../tags/tag1-10.xml"/><Relationship Id="rId21" Type="http://schemas.openxmlformats.org/officeDocument/2006/relationships/tags" Target="../tags/tag1-11.xml"/><Relationship Id="rId23" Type="http://schemas.openxmlformats.org/officeDocument/2006/relationships/tags" Target="../tags/tag1-12.xml"/><Relationship Id="rId25" Type="http://schemas.openxmlformats.org/officeDocument/2006/relationships/tags" Target="../tags/tag1-13.xml"/><Relationship Id="rId2" Type="http://schemas.openxmlformats.org/officeDocument/2006/relationships/image" Target="../media/image-1-1.png"/><Relationship Id="rId4" Type="http://schemas.openxmlformats.org/officeDocument/2006/relationships/image" Target="../media/image-1-2.png"/><Relationship Id="rId6" Type="http://schemas.openxmlformats.org/officeDocument/2006/relationships/image" Target="../media/image-1-3.png"/><Relationship Id="rId8" Type="http://schemas.openxmlformats.org/officeDocument/2006/relationships/image" Target="../media/image-1-4.png"/><Relationship Id="rId10" Type="http://schemas.openxmlformats.org/officeDocument/2006/relationships/image" Target="../media/image-1-5.png"/><Relationship Id="rId12" Type="http://schemas.openxmlformats.org/officeDocument/2006/relationships/image" Target="../media/image-1-6.png"/><Relationship Id="rId14" Type="http://schemas.openxmlformats.org/officeDocument/2006/relationships/image" Target="../media/image-1-7.png"/><Relationship Id="rId16" Type="http://schemas.openxmlformats.org/officeDocument/2006/relationships/image" Target="../media/image-1-8.png"/><Relationship Id="rId18" Type="http://schemas.openxmlformats.org/officeDocument/2006/relationships/image" Target="../media/image-1-9.png"/><Relationship Id="rId20" Type="http://schemas.openxmlformats.org/officeDocument/2006/relationships/image" Target="../media/image-1-10.png"/><Relationship Id="rId22" Type="http://schemas.openxmlformats.org/officeDocument/2006/relationships/image" Target="../media/image-1-11.png"/><Relationship Id="rId24" Type="http://schemas.openxmlformats.org/officeDocument/2006/relationships/image" Target="../media/image-1-12.png"/><Relationship Id="rId26" Type="http://schemas.openxmlformats.org/officeDocument/2006/relationships/slideLayout" Target="../slideLayouts/slideLayout1.xml"/><Relationship Id="rId27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app.biorender.com/illustrations/6515d7eaa43ca9915e304394" TargetMode="External"/><Relationship Id="rId4" Type="http://schemas.openxmlformats.org/officeDocument/2006/relationships/hyperlink" Target="http://www.biorender.com" TargetMode="External"/><Relationship Id="rId7" Type="http://schemas.openxmlformats.org/officeDocument/2006/relationships/hyperlink" Target="https://appsource.microsoft.com/en-us/product/office/wa200006038?src=product&amp;mktcmpid=pptx_export" TargetMode="External"/><Relationship Id="rId1" Type="http://schemas.openxmlformats.org/officeDocument/2006/relationships/image" Target="../media/image-2-1.png"/><Relationship Id="rId2" Type="http://schemas.openxmlformats.org/officeDocument/2006/relationships/image" Target="../media/image-2-2.svg"/><Relationship Id="rId5" Type="http://schemas.openxmlformats.org/officeDocument/2006/relationships/image" Target="../media/image-2-3.png"/><Relationship Id="rId6" Type="http://schemas.openxmlformats.org/officeDocument/2006/relationships/image" Target="../media/image-2-4.sv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0" descr="preencoded.png">    </p:cNvPr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591971" y="1181291"/>
            <a:ext cx="4139184" cy="4105656"/>
          </a:xfrm>
          <a:prstGeom prst="rect">
            <a:avLst/>
          </a:prstGeom>
        </p:spPr>
      </p:pic>
      <p:pic>
        <p:nvPicPr>
          <p:cNvPr id="3" name="Image 1" descr="preencoded.png">    </p:cNvPr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2388107" y="992768"/>
            <a:ext cx="4541520" cy="4526280"/>
          </a:xfrm>
          <a:prstGeom prst="rect">
            <a:avLst/>
          </a:prstGeom>
        </p:spPr>
      </p:pic>
      <p:pic>
        <p:nvPicPr>
          <p:cNvPr id="4" name="Image 2" descr="preencoded.png">    </p:cNvPr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2710479" y="1081123"/>
            <a:ext cx="3895344" cy="4264152"/>
          </a:xfrm>
          <a:prstGeom prst="rect">
            <a:avLst/>
          </a:prstGeom>
        </p:spPr>
      </p:pic>
      <p:sp>
        <p:nvSpPr>
          <p:cNvPr id="5" name="Text 0"/>
          <p:cNvSpPr/>
          <p:nvPr/>
        </p:nvSpPr>
        <p:spPr>
          <a:xfrm>
            <a:off x="3741737" y="3038190"/>
            <a:ext cx="1895060" cy="2857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967" b="1" dirty="0">
                <a:solidFill>
                  <a:srgbClr val="232323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pPACmCherry.v8</a:t>
            </a:r>
            <a:endParaRPr lang="en-US" sz="1967" dirty="0"/>
          </a:p>
        </p:txBody>
      </p:sp>
      <p:sp>
        <p:nvSpPr>
          <p:cNvPr id="6" name="Text 1"/>
          <p:cNvSpPr/>
          <p:nvPr/>
        </p:nvSpPr>
        <p:spPr>
          <a:xfrm>
            <a:off x="5233890" y="1226299"/>
            <a:ext cx="692482" cy="3619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ctin 5' UTR</a:t>
            </a:r>
            <a:endParaRPr lang="en-US" sz="1224" dirty="0"/>
          </a:p>
        </p:txBody>
      </p:sp>
      <p:sp>
        <p:nvSpPr>
          <p:cNvPr id="7" name="Text 2"/>
          <p:cNvSpPr/>
          <p:nvPr/>
        </p:nvSpPr>
        <p:spPr>
          <a:xfrm>
            <a:off x="6370875" y="3252203"/>
            <a:ext cx="812411" cy="3619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ctin 3' UTR</a:t>
            </a:r>
            <a:endParaRPr lang="en-US" sz="1224" dirty="0"/>
          </a:p>
        </p:txBody>
      </p:sp>
      <p:sp>
        <p:nvSpPr>
          <p:cNvPr id="8" name="Text 3"/>
          <p:cNvSpPr/>
          <p:nvPr/>
        </p:nvSpPr>
        <p:spPr>
          <a:xfrm>
            <a:off x="3585276" y="1041554"/>
            <a:ext cx="802226" cy="3619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mpR promoter</a:t>
            </a:r>
            <a:endParaRPr lang="en-US" sz="1224" dirty="0"/>
          </a:p>
        </p:txBody>
      </p:sp>
      <p:pic>
        <p:nvPicPr>
          <p:cNvPr id="9" name="Image 3" descr="preencoded.png">    </p:cNvPr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2485738" y="1055168"/>
            <a:ext cx="4340352" cy="4358640"/>
          </a:xfrm>
          <a:prstGeom prst="rect">
            <a:avLst/>
          </a:prstGeom>
        </p:spPr>
      </p:pic>
      <p:sp>
        <p:nvSpPr>
          <p:cNvPr id="10" name="Text 4"/>
          <p:cNvSpPr/>
          <p:nvPr/>
        </p:nvSpPr>
        <p:spPr>
          <a:xfrm>
            <a:off x="6447191" y="2495267"/>
            <a:ext cx="1126117" cy="542925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Condon-optimized PAC</a:t>
            </a:r>
            <a:endParaRPr lang="en-US" sz="1224" dirty="0"/>
          </a:p>
        </p:txBody>
      </p:sp>
      <p:sp>
        <p:nvSpPr>
          <p:cNvPr id="11" name="Text 5"/>
          <p:cNvSpPr/>
          <p:nvPr/>
        </p:nvSpPr>
        <p:spPr>
          <a:xfrm>
            <a:off x="2699495" y="1759697"/>
            <a:ext cx="812411" cy="35400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mpR </a:t>
            </a:r>
            <a:endParaRPr lang="en-US" sz="1224" dirty="0"/>
          </a:p>
        </p:txBody>
      </p:sp>
      <p:sp>
        <p:nvSpPr>
          <p:cNvPr id="12" name="Text 6"/>
          <p:cNvSpPr/>
          <p:nvPr/>
        </p:nvSpPr>
        <p:spPr>
          <a:xfrm>
            <a:off x="6283555" y="2189896"/>
            <a:ext cx="401893" cy="35400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l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T2A</a:t>
            </a:r>
            <a:endParaRPr lang="en-US" sz="1224" dirty="0"/>
          </a:p>
        </p:txBody>
      </p:sp>
      <p:pic>
        <p:nvPicPr>
          <p:cNvPr id="13" name="Image 4" descr="preencoded.png">    </p:cNvPr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2047498" y="646614"/>
            <a:ext cx="5321808" cy="5327904"/>
          </a:xfrm>
          <a:prstGeom prst="rect">
            <a:avLst/>
          </a:prstGeom>
        </p:spPr>
      </p:pic>
      <p:sp>
        <p:nvSpPr>
          <p:cNvPr id="14" name="Text 7"/>
          <p:cNvSpPr/>
          <p:nvPr/>
        </p:nvSpPr>
        <p:spPr>
          <a:xfrm>
            <a:off x="5926367" y="1721599"/>
            <a:ext cx="873381" cy="180975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l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mCherry</a:t>
            </a:r>
            <a:endParaRPr lang="en-US" sz="1224" dirty="0"/>
          </a:p>
        </p:txBody>
      </p:sp>
      <p:pic>
        <p:nvPicPr>
          <p:cNvPr id="15" name="Image 5" descr="preencoded.png">    </p:cNvPr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979729" y="544679"/>
            <a:ext cx="5376672" cy="5385816"/>
          </a:xfrm>
          <a:prstGeom prst="rect">
            <a:avLst/>
          </a:prstGeom>
        </p:spPr>
      </p:pic>
      <p:pic>
        <p:nvPicPr>
          <p:cNvPr id="16" name="Image 6" descr="preencoded.png">    </p:cNvPr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2027681" y="601100"/>
            <a:ext cx="5300472" cy="5309616"/>
          </a:xfrm>
          <a:prstGeom prst="rect">
            <a:avLst/>
          </a:prstGeom>
        </p:spPr>
      </p:pic>
      <p:sp>
        <p:nvSpPr>
          <p:cNvPr id="17" name="Text 8"/>
          <p:cNvSpPr/>
          <p:nvPr/>
        </p:nvSpPr>
        <p:spPr>
          <a:xfrm>
            <a:off x="2059834" y="2965828"/>
            <a:ext cx="812411" cy="3619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Bacterial </a:t>
            </a:r>
            <a:endParaRPr lang="en-US" sz="1224" dirty="0"/>
          </a:p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Ori</a:t>
            </a:r>
            <a:endParaRPr lang="en-US" sz="1224" dirty="0"/>
          </a:p>
        </p:txBody>
      </p:sp>
      <p:pic>
        <p:nvPicPr>
          <p:cNvPr id="18" name="Image 7" descr="preencoded.png">    </p:cNvPr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2209798" y="727598"/>
            <a:ext cx="4916424" cy="4904232"/>
          </a:xfrm>
          <a:prstGeom prst="rect">
            <a:avLst/>
          </a:prstGeom>
        </p:spPr>
      </p:pic>
      <p:sp>
        <p:nvSpPr>
          <p:cNvPr id="19" name="Text 9"/>
          <p:cNvSpPr/>
          <p:nvPr/>
        </p:nvSpPr>
        <p:spPr>
          <a:xfrm>
            <a:off x="6266100" y="3698707"/>
            <a:ext cx="812411" cy="35400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ttB2</a:t>
            </a:r>
            <a:endParaRPr lang="en-US" sz="1224" dirty="0"/>
          </a:p>
        </p:txBody>
      </p:sp>
      <p:pic>
        <p:nvPicPr>
          <p:cNvPr id="20" name="Image 8" descr="preencoded.png">    </p:cNvPr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2803015" y="1305575"/>
            <a:ext cx="3901440" cy="3919728"/>
          </a:xfrm>
          <a:prstGeom prst="rect">
            <a:avLst/>
          </a:prstGeom>
        </p:spPr>
      </p:pic>
      <p:sp>
        <p:nvSpPr>
          <p:cNvPr id="21" name="Text 10"/>
          <p:cNvSpPr/>
          <p:nvPr/>
        </p:nvSpPr>
        <p:spPr>
          <a:xfrm>
            <a:off x="4421479" y="1226293"/>
            <a:ext cx="812411" cy="35400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ttB4</a:t>
            </a:r>
            <a:endParaRPr lang="en-US" sz="1224" dirty="0"/>
          </a:p>
        </p:txBody>
      </p:sp>
      <p:pic>
        <p:nvPicPr>
          <p:cNvPr id="22" name="Image 9" descr="preencoded.png">    </p:cNvPr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2027727" y="605635"/>
            <a:ext cx="5260848" cy="5215128"/>
          </a:xfrm>
          <a:prstGeom prst="rect">
            <a:avLst/>
          </a:prstGeom>
        </p:spPr>
      </p:pic>
      <p:pic>
        <p:nvPicPr>
          <p:cNvPr id="23" name="Image 10" descr="preencoded.png">    </p:cNvPr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2356911" y="783943"/>
            <a:ext cx="4602480" cy="4858512"/>
          </a:xfrm>
          <a:prstGeom prst="rect">
            <a:avLst/>
          </a:prstGeom>
        </p:spPr>
      </p:pic>
      <p:pic>
        <p:nvPicPr>
          <p:cNvPr id="24" name="Image 11" descr="preencoded.png">    </p:cNvPr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1925954" y="487943"/>
            <a:ext cx="5446776" cy="5440680"/>
          </a:xfrm>
          <a:prstGeom prst="rect">
            <a:avLst/>
          </a:prstGeom>
        </p:spPr>
      </p:pic>
      <p:sp>
        <p:nvSpPr>
          <p:cNvPr id="25" name="Text 11"/>
          <p:cNvSpPr/>
          <p:nvPr/>
        </p:nvSpPr>
        <p:spPr>
          <a:xfrm>
            <a:off x="6266103" y="4013578"/>
            <a:ext cx="812411" cy="3619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ct val="97750"/>
              </a:lnSpc>
              <a:buNone/>
            </a:pPr>
            <a:r>
              <a:rPr lang="en-US" sz="1224" dirty="0">
                <a:solidFill>
                  <a:srgbClr val="17171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SV40 poly (A) signal</a:t>
            </a:r>
            <a:endParaRPr lang="en-US" sz="1224" dirty="0"/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0"/>
          <p:cNvSpPr/>
          <p:nvPr/>
        </p:nvSpPr>
        <p:spPr>
          <a:xfrm>
            <a:off x="6126480" y="640080"/>
            <a:ext cx="2560320" cy="5120640"/>
          </a:xfrm>
          <a:custGeom>
            <a:avLst/>
            <a:gdLst/>
            <a:ahLst/>
            <a:cxnLst/>
            <a:rect l="l" t="t" r="r" b="b"/>
            <a:pathLst>
              <a:path w="2560320" h="5120640">
                <a:moveTo>
                  <a:pt x="0" y="0"/>
                </a:moveTo>
                <a:lnTo>
                  <a:pt x="0" y="5120640"/>
                </a:lnTo>
                <a:lnTo>
                  <a:pt x="2560320" y="5120640"/>
                </a:lnTo>
                <a:lnTo>
                  <a:pt x="2560320" y="256032"/>
                </a:lnTo>
                <a:lnTo>
                  <a:pt x="2304288" y="0"/>
                </a:lnTo>
                <a:close/>
              </a:path>
            </a:pathLst>
          </a:custGeom>
          <a:solidFill>
            <a:srgbClr val="E9F0F8"/>
          </a:solidFill>
          <a:ln/>
          <a:effectLst>
            <a:outerShdw sx="100000" sy="100000" kx="0" ky="0" algn="bl" rotWithShape="0" blurRad="7112" dist="14224" dir="2700000">
              <a:srgbClr val="000000">
                <a:alpha val="12000"/>
              </a:srgbClr>
            </a:outerShdw>
          </a:effectLst>
        </p:spPr>
      </p:sp>
      <p:sp>
        <p:nvSpPr>
          <p:cNvPr id="3" name="Shape 1"/>
          <p:cNvSpPr/>
          <p:nvPr/>
        </p:nvSpPr>
        <p:spPr>
          <a:xfrm>
            <a:off x="8430768" y="640080"/>
            <a:ext cx="256032" cy="307238"/>
          </a:xfrm>
          <a:custGeom>
            <a:avLst/>
            <a:gdLst/>
            <a:ahLst/>
            <a:cxnLst/>
            <a:rect l="l" t="t" r="r" b="b"/>
            <a:pathLst>
              <a:path w="256032" h="307238">
                <a:moveTo>
                  <a:pt x="0" y="0"/>
                </a:moveTo>
                <a:lnTo>
                  <a:pt x="102413" y="307238"/>
                </a:lnTo>
                <a:lnTo>
                  <a:pt x="256032" y="256032"/>
                </a:lnTo>
                <a:close/>
              </a:path>
            </a:pathLst>
          </a:custGeom>
          <a:solidFill>
            <a:srgbClr val="92B7DB"/>
          </a:solidFill>
          <a:ln/>
        </p:spPr>
      </p:sp>
      <p:sp>
        <p:nvSpPr>
          <p:cNvPr id="4" name="Shape 2"/>
          <p:cNvSpPr/>
          <p:nvPr/>
        </p:nvSpPr>
        <p:spPr>
          <a:xfrm>
            <a:off x="8430768" y="640080"/>
            <a:ext cx="256032" cy="256032"/>
          </a:xfrm>
          <a:custGeom>
            <a:avLst/>
            <a:gdLst/>
            <a:ahLst/>
            <a:cxnLst/>
            <a:rect l="l" t="t" r="r" b="b"/>
            <a:pathLst>
              <a:path w="256032" h="256032">
                <a:moveTo>
                  <a:pt x="0" y="0"/>
                </a:moveTo>
                <a:lnTo>
                  <a:pt x="38405" y="256032"/>
                </a:lnTo>
                <a:lnTo>
                  <a:pt x="256032" y="256032"/>
                </a:lnTo>
                <a:close/>
              </a:path>
            </a:pathLst>
          </a:custGeom>
          <a:solidFill>
            <a:srgbClr val="CCD8E7"/>
          </a:solidFill>
          <a:ln/>
        </p:spPr>
      </p:sp>
      <p:pic>
        <p:nvPicPr>
          <p:cNvPr id="5" name="Image 0" descr="https://assets.cdn.biorender.com/assets/biorender-logo-blue.svg?cacheBust=0.22810818956319945">    </p:cNvPr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457200" y="2162395"/>
            <a:ext cx="614477" cy="519002"/>
          </a:xfrm>
          <a:prstGeom prst="rect">
            <a:avLst/>
          </a:prstGeom>
        </p:spPr>
      </p:pic>
      <p:sp>
        <p:nvSpPr>
          <p:cNvPr id="6" name="Text 3"/>
          <p:cNvSpPr/>
          <p:nvPr/>
        </p:nvSpPr>
        <p:spPr>
          <a:xfrm>
            <a:off x="457200" y="2940899"/>
            <a:ext cx="4114800" cy="288036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l" indent="0" marL="0">
              <a:buNone/>
            </a:pPr>
            <a:r>
              <a:rPr lang="en-US" sz="1008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This presentation was created in BioRender</a:t>
            </a:r>
            <a:endParaRPr lang="en-US" sz="1008" dirty="0"/>
          </a:p>
          <a:p>
            <a:pPr algn="l" indent="0" marL="0">
              <a:buNone/>
            </a:pPr>
            <a:r>
              <a:rPr lang="en-US" sz="1008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 </a:t>
            </a:r>
            <a:endParaRPr lang="en-US" sz="1008" dirty="0"/>
          </a:p>
          <a:p>
            <a:pPr algn="l" indent="0" marL="0">
              <a:buNone/>
            </a:pPr>
            <a:r>
              <a:rPr lang="en-US" sz="1008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To access the original source of this presentation, visit:</a:t>
            </a:r>
            <a:endParaRPr lang="en-US" sz="1008" dirty="0"/>
          </a:p>
          <a:p>
            <a:pPr algn="l" indent="0" marL="0">
              <a:buNone/>
            </a:pPr>
            <a:r>
              <a:rPr lang="en-US" sz="1008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 </a:t>
            </a:r>
            <a:endParaRPr lang="en-US" sz="1008" dirty="0"/>
          </a:p>
          <a:p>
            <a:pPr algn="l" indent="0" marL="0">
              <a:buNone/>
            </a:pPr>
            <a:r>
              <a:rPr lang="en-US" sz="1008" u="sng" dirty="0">
                <a:solidFill>
                  <a:srgbClr val="085299"/>
                </a:solidFill>
                <a:latin typeface="Roboto" pitchFamily="34" charset="0"/>
                <a:ea typeface="Roboto" pitchFamily="34" charset="-122"/>
                <a:cs typeface="Roboto" pitchFamily="34" charset="-120"/>
                <a:hlinkClick r:id="rId3" invalidUrl="" action="" tgtFrame="" tooltip="" history="1" highlightClick="0" endSnd="0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app.biorender.com/illustrations/6515d7eaa43ca9915e304394</a:t>
            </a:r>
            <a:endParaRPr lang="en-US" sz="1008" dirty="0"/>
          </a:p>
          <a:p>
            <a:pPr algn="l" indent="0" marL="0">
              <a:buNone/>
            </a:pPr>
            <a:r>
              <a:rPr lang="en-US" sz="1008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 </a:t>
            </a:r>
            <a:endParaRPr lang="en-US" sz="1008" dirty="0"/>
          </a:p>
          <a:p>
            <a:pPr algn="l" indent="0" marL="0">
              <a:buNone/>
            </a:pPr>
            <a:r>
              <a:rPr lang="en-US" sz="1008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Sign up for your own BioRender account at </a:t>
            </a:r>
            <a:pPr algn="l" indent="0" marL="0">
              <a:buNone/>
            </a:pPr>
            <a:r>
              <a:rPr lang="en-US" sz="1008" u="sng" dirty="0">
                <a:solidFill>
                  <a:srgbClr val="085299"/>
                </a:solidFill>
                <a:latin typeface="Roboto" pitchFamily="34" charset="0"/>
                <a:ea typeface="Roboto" pitchFamily="34" charset="-122"/>
                <a:cs typeface="Roboto" pitchFamily="34" charset="-120"/>
                <a:hlinkClick r:id="rId4" invalidUrl="" action="" tgtFrame="" tooltip="" history="1" highlightClick="0" endSnd="0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www.biorender.com</a:t>
            </a:r>
            <a:endParaRPr lang="en-US" sz="1008" dirty="0"/>
          </a:p>
        </p:txBody>
      </p:sp>
      <p:pic>
        <p:nvPicPr>
          <p:cNvPr id="7" name="Image 1" descr="https://assets.cdn.biorender.com/assets/office/biorender-ppt-lockup.svg?cacheBust=0.8263480887353265">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717197" y="998525"/>
            <a:ext cx="1378886" cy="597271"/>
          </a:xfrm>
          <a:prstGeom prst="rect">
            <a:avLst/>
          </a:prstGeom>
        </p:spPr>
      </p:pic>
      <p:sp>
        <p:nvSpPr>
          <p:cNvPr id="8" name="Text 4"/>
          <p:cNvSpPr/>
          <p:nvPr/>
        </p:nvSpPr>
        <p:spPr>
          <a:xfrm>
            <a:off x="6382512" y="1766621"/>
            <a:ext cx="2048256" cy="3584448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lnSpc>
                <a:spcPts val="1120"/>
              </a:lnSpc>
              <a:buNone/>
            </a:pPr>
            <a:r>
              <a:rPr lang="en-US" sz="896" dirty="0">
                <a:solidFill>
                  <a:srgbClr val="085299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Get the BioRender Add-in for PowerPoint</a:t>
            </a:r>
            <a:endParaRPr lang="en-US" sz="812" dirty="0"/>
          </a:p>
          <a:p>
            <a:pPr algn="l" indent="0" marL="0">
              <a:lnSpc>
                <a:spcPts val="1400"/>
              </a:lnSpc>
              <a:buNone/>
            </a:pPr>
            <a:endParaRPr lang="en-US" sz="812" dirty="0"/>
          </a:p>
          <a:p>
            <a:pPr algn="l" indent="0" marL="0">
              <a:lnSpc>
                <a:spcPts val="1120"/>
              </a:lnSpc>
              <a:buNone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Our integration allows you to unlock the power of BioRender, right inside PowerPoint:</a:t>
            </a:r>
            <a:endParaRPr lang="en-US" sz="812" dirty="0"/>
          </a:p>
          <a:p>
            <a:pPr algn="l" indent="0" marL="0">
              <a:lnSpc>
                <a:spcPts val="1120"/>
              </a:lnSpc>
              <a:buNone/>
            </a:pP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Export your BioRender presentation as an editable .PPTX file.</a:t>
            </a: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Edit BioRender figures without leaving your PowerPoint slides.</a:t>
            </a: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Sync updates from BioRender with just one click.</a:t>
            </a: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Effortlessly manage sharing and permissions with your team.</a:t>
            </a: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Access your entire BioRender library at your fingertips.</a:t>
            </a:r>
            <a:endParaRPr lang="en-US" sz="812" dirty="0"/>
          </a:p>
          <a:p>
            <a:pPr algn="l" lvl="1" marL="254000" indent="-127000">
              <a:lnSpc>
                <a:spcPts val="1120"/>
              </a:lnSpc>
              <a:buSzPct val="100000"/>
              <a:buChar char="●"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Need a transparent background? Toggle it on or off, anytime.</a:t>
            </a:r>
            <a:endParaRPr lang="en-US" sz="812" dirty="0"/>
          </a:p>
          <a:p>
            <a:pPr algn="l" indent="0" marL="0">
              <a:lnSpc>
                <a:spcPts val="1120"/>
              </a:lnSpc>
              <a:buNone/>
            </a:pPr>
            <a:endParaRPr lang="en-US" sz="812" dirty="0"/>
          </a:p>
          <a:p>
            <a:pPr algn="l" indent="0" marL="0">
              <a:lnSpc>
                <a:spcPts val="1120"/>
              </a:lnSpc>
              <a:buNone/>
            </a:pPr>
            <a:r>
              <a:rPr lang="en-US" sz="812" dirty="0">
                <a:solidFill>
                  <a:srgbClr val="383F47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BioRender for PowerPoint is hosted safely and securely in the Microsoft AppSource.</a:t>
            </a:r>
            <a:endParaRPr lang="en-US" sz="812" dirty="0"/>
          </a:p>
        </p:txBody>
      </p:sp>
      <p:sp>
        <p:nvSpPr>
          <p:cNvPr id="9" name="Text 5"/>
          <p:cNvSpPr/>
          <p:nvPr/>
        </p:nvSpPr>
        <p:spPr>
          <a:xfrm>
            <a:off x="6766560" y="4890211"/>
            <a:ext cx="1280160" cy="256032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 algn="ctr" indent="0" marL="0">
              <a:buNone/>
            </a:pPr>
            <a:r>
              <a:rPr lang="en-US" sz="896" b="1" dirty="0">
                <a:solidFill>
                  <a:srgbClr val="085299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Get the add-in now:</a:t>
            </a:r>
            <a:endParaRPr lang="en-US" sz="896" dirty="0"/>
          </a:p>
        </p:txBody>
      </p:sp>
      <p:sp>
        <p:nvSpPr>
          <p:cNvPr id="10" name="Text 6">
            <a:hlinkClick r:id="rId7" tooltip=""/>
          </p:cNvPr>
          <p:cNvSpPr/>
          <p:nvPr/>
        </p:nvSpPr>
        <p:spPr>
          <a:xfrm>
            <a:off x="6382512" y="5146243"/>
            <a:ext cx="2048256" cy="512064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algn="ctr" indent="0" marL="0">
              <a:buNone/>
            </a:pPr>
            <a:r>
              <a:rPr lang="en-US" sz="672" u="sng" dirty="0">
                <a:solidFill>
                  <a:srgbClr val="085299"/>
                </a:solidFill>
                <a:latin typeface="Roboto" pitchFamily="34" charset="0"/>
                <a:ea typeface="Roboto" pitchFamily="34" charset="-122"/>
                <a:cs typeface="Roboto" pitchFamily="34" charset="-120"/>
                <a:hlinkClick r:id="rId7" invalidUrl="" action="" tgtFrame="" tooltip="" history="1" highlightClick="0" endSnd="0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appsource.microsoft.com/en-us/product/office/wa200006038?src=product&amp;mktcmpid=pptx_export</a:t>
            </a:r>
            <a:endParaRPr lang="en-US" sz="672" dirty="0"/>
          </a:p>
        </p:txBody>
      </p:sp>
    </p:spTree>
  </p:cSld>
  <p:clrMapOvr>
    <a:masterClrMapping/>
  </p:clrMapOvr>
</p:sld>
</file>

<file path=ppt/tags/tag1-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XPORTMETHOD" val="pptx_export_from_biorender"/>
  <p:tag name="ILLUSTRATIONID" val="6515d7eaa43ca9915e304394"/>
  <p:tag name="SLIDEID" val="2d11619c-823a-4104-8a42-ce221ab3d5c8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666f611d-7129-4e83-a890-dbcb15632a54&quot;:{&quot;id&quot;:&quot;666f611d-7129-4e83-a890-dbcb15632a54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2d11619c-823a-4104-8a42-ce221ab3d5c8&quot;,&quot;type&quot;:&quot;FRAME&quot;,&quot;order&quot;:&quot;5&quot;}},&quot;3959677e-9b59-4bcb-bdea-f67a04126903&quot;:{&quot;type&quot;:&quot;FIGURE_OBJECT&quot;,&quot;id&quot;:&quot;3959677e-9b59-4bcb-bdea-f67a04126903&quot;,&quot;relativeTransform&quot;:{&quot;translate&quot;:{&quot;x&quot;:9.119897036281104,&quot;y&quot;:5.827652263700765},&quot;rotate&quot;:-1.395476572154996,&quot;skewX&quot;:6.106226635438382e-16,&quot;scale&quot;:{&quot;x&quot;:0.9999999999999983,&quot;y&quot;:1.0000000000000018}},&quot;opacity&quot;:1,&quot;path&quot;:{&quot;type&quot;:&quot;ARC&quot;,&quot;size&quot;:{&quot;x&quot;:368.22244650883835,&quot;y&quot;:370.24850074172286},&quot;startAngle&quot;:1.3218378441210106,&quot;sweepAngle&quot;:0.28674848405793996},&quot;pathStyles&quot;:[{&quot;type&quot;:&quot;FILL&quot;,&quot;fillStyle&quot;:&quot;transparent&quot;},{&quot;type&quot;:&quot;STROKE&quot;,&quot;strokeStyle&quot;:&quot;rgb(187, 187, 188)&quot;,&quot;lineWidth&quot;:20.7093848222138,&quot;lineJoin&quot;:&quot;round&quot;}],&quot;isLocked&quot;:false,&quot;parent&quot;:{&quot;type&quot;:&quot;CHILD&quot;,&quot;parentId&quot;:&quot;2d11619c-823a-4104-8a42-ce221ab3d5c8&quot;,&quot;order&quot;:&quot;05&quot;}},&quot;bfe4d7b9-94b1-4a0a-878d-5b40ea996994&quot;:{&quot;type&quot;:&quot;FIGURE_OBJECT&quot;,&quot;id&quot;:&quot;bfe4d7b9-94b1-4a0a-878d-5b40ea996994&quot;,&quot;relativeTransform&quot;:{&quot;translate&quot;:{&quot;x&quot;:9.044738536339935,&quot;y&quot;:1.3437487480274726},&quot;rotate&quot;:0.10371817069197634,&quot;skewX&quot;:2.359223927328458e-16,&quot;scale&quot;:{&quot;x&quot;:0.9999999999999999,&quot;y&quot;:1}},&quot;opacity&quot;:1,&quot;path&quot;:{&quot;type&quot;:&quot;ARC&quot;,&quot;size&quot;:{&quot;x&quot;:-368.22244650883727,&quot;y&quot;:370.24850074172355},&quot;startAngle&quot;:-1.011823141890489,&quot;sweepAngle&quot;:0.7346009597182785,&quot;selectedObjectIds&quot;:[&quot;62b788f0-6e5e-4305-8250-e6a00a392386&quot;]},&quot;pathStyles&quot;:[{&quot;type&quot;:&quot;FILL&quot;,&quot;fillStyle&quot;:&quot;rgba(0,0,0,0)&quot;},{&quot;type&quot;:&quot;STROKE&quot;,&quot;strokeStyle&quot;:&quot;rgb(57, 201, 0)&quot;,&quot;lineWidth&quot;:20.7093848222137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1&quot;}},&quot;9fbe4a88-046c-488a-b218-c27831bd6686&quot;:{&quot;type&quot;:&quot;FIGURE_OBJECT&quot;,&quot;id&quot;:&quot;9fbe4a88-046c-488a-b218-c27831bd6686&quot;,&quot;relativeTransform&quot;:{&quot;translate&quot;:{&quot;x&quot;:12.311533711813667,&quot;y&quot;:-2.029966401025318},&quot;rotate&quot;:0,&quot;skewX&quot;:0,&quot;scale&quot;:{&quot;x&quot;:1,&quot;y&quot;:1}},&quot;opacity&quot;:1,&quot;pathStyles&quot;:[{&quot;type&quot;:&quot;FILL&quot;,&quot;fillStyle&quot;:&quot;#232323&quot;}],&quot;text&quot;:{&quot;textData&quot;:{&quot;lineSpacing&quot;:&quot;normal&quot;,&quot;alignment&quot;:&quot;center&quot;,&quot;lines&quot;:[{&quot;runs&quot;:[{&quot;style&quot;:{&quot;fontFamily&quot;:&quot;Roboto&quot;,&quot;fontSize&quot;:26.22531739122253,&quot;color&quot;:&quot;#232323&quot;,&quot;fontWeight&quot;:&quot;bold&quot;,&quot;fontStyle&quot;:&quot;normal&quot;,&quot;decoration&quot;:&quot;none&quot;,&quot;script&quot;:&quot;none&quot;},&quot;range&quot;:[0,13]}],&quot;text&quot;:&quot;pPACmCherry.v8&quot;}],&quot;verticalAlign&quot;:&quot;TOP&quot;,&quot;_lastCaretLocation&quot;:{&quot;lineIndex&quot;:0,&quot;runIndex&quot;:-1,&quot;charIndex&quot;:-1,&quot;endOfLine&quot;:true}},&quot;size&quot;:{&quot;x&quot;:198.9564208984375,&quot;y&quot;:30},&quot;targetSize&quot;:{&quot;x&quot;:148.98127824446283,&quot;y&quot;:29.372355478169233},&quot;format&quot;:&quot;BETTER_TEXT&quot;,&quot;verticalAlign&quot;:&quot;TOP&quot;},&quot;isLocked&quot;:false,&quot;parent&quot;:{&quot;type&quot;:&quot;CHILD&quot;,&quot;parentId&quot;:&quot;2d11619c-823a-4104-8a42-ce221ab3d5c8&quot;,&quot;order&quot;:&quot;15&quot;}},&quot;bc3236cd-a66d-45a1-b68e-acf7e81f6c45&quot;:{&quot;type&quot;:&quot;FIGURE_OBJECT&quot;,&quot;id&quot;:&quot;bc3236cd-a66d-45a1-b68e-acf7e81f6c45&quot;,&quot;relativeTransform&quot;:{&quot;translate&quot;:{&quot;x&quot;:105.84055869474152,&quot;y&quot;:-188.25465614488613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11]}],&quot;text&quot;:&quot;Actin 5' UTR&quot;}],&quot;verticalAlign&quot;:&quot;TOP&quot;,&quot;_lastCaretLocation&quot;:{&quot;lineIndex&quot;:0,&quot;runIndex&quot;:0,&quot;charIndex&quot;:8}},&quot;size&quot;:{&quot;x&quot;:72.70150625054826,&quot;y&quot;:38},&quot;targetSize&quot;:{&quot;x&quot;:72.70150625054826,&quot;y&quot;:38},&quot;format&quot;:&quot;BETTER_TEXT&quot;,&quot;verticalAlign&quot;:&quot;TOP&quot;},&quot;isLocked&quot;:false,&quot;parent&quot;:{&quot;type&quot;:&quot;CHILD&quot;,&quot;parentId&quot;:&quot;2d11619c-823a-4104-8a42-ce221ab3d5c8&quot;,&quot;order&quot;:&quot;2&quot;}},&quot;c2da200a-d407-496a-8da4-36642197cf13&quot;:{&quot;type&quot;:&quot;FIGURE_OBJECT&quot;,&quot;id&quot;:&quot;c2da200a-d407-496a-8da4-36642197cf13&quot;,&quot;relativeTransform&quot;:{&quot;translate&quot;:{&quot;x&quot;:231.50447820992022,&quot;y&quot;:24.438661381778413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11]}],&quot;text&quot;:&quot;Actin 3' UTR&quot;}],&quot;verticalAlign&quot;:&quot;TOP&quot;,&quot;_lastCaretLocation&quot;:{&quot;lineIndex&quot;:0,&quot;runIndex&quot;:-1,&quot;charIndex&quot;:-1,&quot;endOfLine&quot;:true}},&quot;size&quot;:{&quot;x&quot;:85.29250625054824,&quot;y&quot;:38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25&quot;}},&quot;fe5fbdc8-7c46-4050-8470-c1a57bbbe5c2&quot;:{&quot;type&quot;:&quot;FIGURE_OBJECT&quot;,&quot;id&quot;:&quot;fe5fbdc8-7c46-4050-8470-c1a57bbbe5c2&quot;,&quot;relativeTransform&quot;:{&quot;translate&quot;:{&quot;x&quot;:-61.4814601115105,&quot;y&quot;:-207.65052943647123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12]}],&quot;text&quot;:&quot;AmpR promoter&quot;}],&quot;verticalAlign&quot;:&quot;TOP&quot;,&quot;_lastCaretLocation&quot;:{&quot;lineIndex&quot;:0,&quot;runIndex&quot;:-1,&quot;charIndex&quot;:-1,&quot;endOfLine&quot;:true}},&quot;size&quot;:{&quot;x&quot;:84.2231841019787,&quot;y&quot;:38},&quot;targetSize&quot;:{&quot;x&quot;:84.2231841019787,&quot;y&quot;:38},&quot;format&quot;:&quot;BETTER_TEXT&quot;,&quot;verticalAlign&quot;:&quot;TOP&quot;},&quot;isLocked&quot;:false,&quot;parent&quot;:{&quot;type&quot;:&quot;CHILD&quot;,&quot;parentId&quot;:&quot;2d11619c-823a-4104-8a42-ce221ab3d5c8&quot;,&quot;order&quot;:&quot;3&quot;}},&quot;fff3ae6c-3715-410a-8953-183722223959&quot;:{&quot;type&quot;:&quot;FIGURE_OBJECT&quot;,&quot;id&quot;:&quot;fff3ae6c-3715-410a-8953-183722223959&quot;,&quot;relativeTransform&quot;:{&quot;translate&quot;:{&quot;x&quot;:8.809915832517655,&quot;y&quot;:3.5787805784530278},&quot;rotate&quot;:3.0220048013693326,&quot;skewX&quot;:-3.1918911957973324e-16,&quot;scale&quot;:{&quot;x&quot;:0.9999999999999988,&quot;y&quot;:1.0000000000000004}},&quot;opacity&quot;:1,&quot;path&quot;:{&quot;type&quot;:&quot;ARC&quot;,&quot;size&quot;:{&quot;x&quot;:368.2224465088382,&quot;y&quot;:370.2485007417228},&quot;startAngle&quot;:2.244957916149851,&quot;sweepAngle&quot;:0.42852270390369274,&quot;selectedObjectIds&quot;:[&quot;17ff5de1-2446-41ea-8fef-13f788b89690&quot;]},&quot;pathStyles&quot;:[{&quot;type&quot;:&quot;FILL&quot;,&quot;fillStyle&quot;:&quot;rgba(0,0,0,0)&quot;},{&quot;type&quot;:&quot;STROKE&quot;,&quot;strokeStyle&quot;:&quot;rgba(168,88,150,1)&quot;,&quot;lineWidth&quot;:20.709384822213796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5&quot;}},&quot;8394538e-e4a7-482e-80ba-c9165bd21f60&quot;:{&quot;type&quot;:&quot;FIGURE_OBJECT&quot;,&quot;id&quot;:&quot;8394538e-e4a7-482e-80ba-c9165bd21f60&quot;,&quot;relativeTransform&quot;:{&quot;translate&quot;:{&quot;x&quot;:255.98417554984906,&quot;y&quot;:-45.52972446327783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19]}],&quot;text&quot;:&quot;Condon-optimized PAC&quot;}],&quot;verticalAlign&quot;:&quot;TOP&quot;,&quot;_lastCaretLocation&quot;:{&quot;lineIndex&quot;:0,&quot;runIndex&quot;:0,&quot;charIndex&quot;:17}},&quot;size&quot;:{&quot;x&quot;:118.22749328613278,&quot;y&quot;:57},&quot;targetSize&quot;:{&quot;x&quot;:118.22749328613278,&quot;y&quot;:57},&quot;format&quot;:&quot;BETTER_TEXT&quot;,&quot;verticalAlign&quot;:&quot;TOP&quot;},&quot;isLocked&quot;:false,&quot;parent&quot;:{&quot;type&quot;:&quot;CHILD&quot;,&quot;parentId&quot;:&quot;2d11619c-823a-4104-8a42-ce221ab3d5c8&quot;,&quot;order&quot;:&quot;52&quot;}},&quot;5cfe2722-693a-4bb6-9212-6b11364dea1d&quot;:{&quot;type&quot;:&quot;FIGURE_OBJECT&quot;,&quot;id&quot;:&quot;5cfe2722-693a-4bb6-9212-6b11364dea1d&quot;,&quot;relativeTransform&quot;:{&quot;translate&quot;:{&quot;x&quot;:-153.94216903169928,&quot;y&quot;:-132.67225370443344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4]}],&quot;text&quot;:&quot;AmpR &quot;}],&quot;verticalAlign&quot;:&quot;TOP&quot;,&quot;_lastCaretLocation&quot;:{&quot;lineIndex&quot;:0,&quot;runIndex&quot;:-1,&quot;charIndex&quot;:-1,&quot;endOfLine&quot;:true}},&quot;size&quot;:{&quot;x&quot;:85.29250625054824,&quot;y&quot;:37.165367090997385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6&quot;}},&quot;940625db-7f04-412c-8bf6-f1e1c5957e84&quot;:{&quot;type&quot;:&quot;FIGURE_OBJECT&quot;,&quot;id&quot;:&quot;940625db-7f04-412c-8bf6-f1e1c5957e84&quot;,&quot;relativeTransform&quot;:{&quot;translate&quot;:{&quot;x&quot;:200.78755869474148,&quot;y&quot;:-87.50697259938745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left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2]}],&quot;text&quot;:&quot;T2A&quot;,&quot;base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}],&quot;verticalAlign&quot;:&quot;TOP&quot;,&quot;_lastCaretLocation&quot;:{&quot;lineIndex&quot;:0,&quot;runIndex&quot;:-1,&quot;charIndex&quot;:-1,&quot;endOfLine&quot;:true}},&quot;size&quot;:{&quot;x&quot;:42.193506250548246,&quot;y&quot;:37.165367090997385},&quot;targetSize&quot;:{&quot;x&quot;:42.19350625054824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65&quot;}},&quot;f499de73-cfb7-4cb7-bad8-4765023cc7b3&quot;:{&quot;type&quot;:&quot;FIGURE_OBJECT&quot;,&quot;id&quot;:&quot;f499de73-cfb7-4cb7-bad8-4765023cc7b3&quot;,&quot;relativeTransform&quot;:{&quot;translate&quot;:{&quot;x&quot;:14.320413656486734,&quot;y&quot;:11.566031506549923},&quot;rotate&quot;:-0.5107524405069679,&quot;skewX&quot;:-5.5511151231257975e-16,&quot;scale&quot;:{&quot;x&quot;:0.9999999999999987,&quot;y&quot;:1.0000000000000016}},&quot;opacity&quot;:1,&quot;path&quot;:{&quot;type&quot;:&quot;ARC&quot;,&quot;size&quot;:{&quot;x&quot;:368.22244650883835,&quot;y&quot;:370.24850074172286},&quot;startAngle&quot;:-0.142227607492806,&quot;sweepAngle&quot;:0.14222760749280638,&quot;selectedObjectIds&quot;:[&quot;45050643-6f10-4231-a719-8b5f434b9633&quot;]},&quot;pathStyles&quot;:[{&quot;type&quot;:&quot;FILL&quot;,&quot;fillStyle&quot;:&quot;rgba(0,0,0,0)&quot;},{&quot;type&quot;:&quot;STROKE&quot;,&quot;strokeStyle&quot;:&quot;rgb(221, 176, 236)&quot;,&quot;lineWidth&quot;:20.7093848222138,&quot;lineJoin&quot;:&quot;round&quot;}],&quot;isLocked&quot;:false,&quot;parent&quot;:{&quot;type&quot;:&quot;CHILD&quot;,&quot;parentId&quot;:&quot;2d11619c-823a-4104-8a42-ce221ab3d5c8&quot;,&quot;order&quot;:&quot;7&quot;}},&quot;4e4ae60e-3f30-47f7-ba1c-c0c626075cac&quot;:{&quot;type&quot;:&quot;FIGURE_OBJECT&quot;,&quot;id&quot;:&quot;4e4ae60e-3f30-47f7-ba1c-c0c626075cac&quot;,&quot;relativeTransform&quot;:{&quot;translate&quot;:{&quot;x&quot;:188.03755869474145,&quot;y&quot;:-145.75465614488616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left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6]}],&quot;text&quot;:&quot;mCherry&quot;}],&quot;verticalAlign&quot;:&quot;TOP&quot;,&quot;_lastCaretLocation&quot;:{&quot;lineIndex&quot;:0,&quot;runIndex&quot;:0,&quot;charIndex&quot;:19}},&quot;size&quot;:{&quot;x&quot;:91.69350625054818,&quot;y&quot;:19.000000000000007},&quot;targetSize&quot;:{&quot;x&quot;:91.69350625054818,&quot;y&quot;:19.000000000000007},&quot;format&quot;:&quot;BETTER_TEXT&quot;,&quot;verticalAlign&quot;:&quot;TOP&quot;},&quot;isLocked&quot;:false,&quot;parent&quot;:{&quot;type&quot;:&quot;CHILD&quot;,&quot;parentId&quot;:&quot;2d11619c-823a-4104-8a42-ce221ab3d5c8&quot;,&quot;order&quot;:&quot;72&quot;}},&quot;4a4f5527-4576-4146-ad12-fe66fae898a8&quot;:{&quot;type&quot;:&quot;FIGURE_OBJECT&quot;,&quot;id&quot;:&quot;4a4f5527-4576-4146-ad12-fe66fae898a8&quot;,&quot;relativeTransform&quot;:{&quot;translate&quot;:{&quot;x&quot;:10.085575575974623,&quot;y&quot;:3.9041381323288578},&quot;rotate&quot;:0.5515993360694178,&quot;skewX&quot;:-3.3306690738754844e-16,&quot;scale&quot;:{&quot;x&quot;:0.9999999999999978,&quot;y&quot;:1.0000000000000022}},&quot;opacity&quot;:1,&quot;path&quot;:{&quot;type&quot;:&quot;ARC&quot;,&quot;size&quot;:{&quot;x&quot;:368.2224465088381,&quot;y&quot;:370.24850074172286},&quot;startAngle&quot;:-1.011823141890489,&quot;sweepAngle&quot;:0.4046694364445518,&quot;selectedObjectIds&quot;:[&quot;3fb8d86a-7a97-43a5-8e88-00516e822c20&quot;]},&quot;pathStyles&quot;:[{&quot;type&quot;:&quot;FILL&quot;,&quot;fillStyle&quot;:&quot;rgba(0,0,0,0)&quot;},{&quot;type&quot;:&quot;STROKE&quot;,&quot;strokeStyle&quot;:&quot;rgba(49,126,194,1)&quot;,&quot;lineWidth&quot;:20.7093848222138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75&quot;}},&quot;a4dd9b9c-51fc-4392-ba67-afb0526a957e&quot;:{&quot;type&quot;:&quot;FIGURE_OBJECT&quot;,&quot;id&quot;:&quot;a4dd9b9c-51fc-4392-ba67-afb0526a957e&quot;,&quot;relativeTransform&quot;:{&quot;translate&quot;:{&quot;x&quot;:9.402887282173765,&quot;y&quot;:3.5400783728621352},&quot;rotate&quot;:-3.027313591028833,&quot;skewX&quot;:2.775557561562899e-17,&quot;scale&quot;:{&quot;x&quot;:0.9999999999999987,&quot;y&quot;:1}},&quot;opacity&quot;:1,&quot;path&quot;:{&quot;type&quot;:&quot;ELLIPSE&quot;,&quot;size&quot;:{&quot;x&quot;:372.772384672125,&quot;y&quot;:368.63098103450176}},&quot;pathStyles&quot;:[{&quot;type&quot;:&quot;FILL&quot;,&quot;fillStyle&quot;:&quot;transparent&quot;},{&quot;type&quot;:&quot;STROKE&quot;,&quot;strokeStyle&quot;:&quot;rgba(160,160,160,1)&quot;,&quot;lineWidth&quot;:4.14187696444276,&quot;lineJoin&quot;:&quot;round&quot;}],&quot;isLocked&quot;:false,&quot;parent&quot;:{&quot;type&quot;:&quot;CHILD&quot;,&quot;parentId&quot;:&quot;2d11619c-823a-4104-8a42-ce221ab3d5c8&quot;,&quot;order&quot;:&quot;02&quot;}},&quot;3c35e9ea-90c5-4097-9336-4edc9a629d73&quot;:{&quot;type&quot;:&quot;FIGURE_OBJECT&quot;,&quot;id&quot;:&quot;3c35e9ea-90c5-4097-9336-4edc9a629d73&quot;,&quot;relativeTransform&quot;:{&quot;translate&quot;:{&quot;x&quot;:11.119897036281188,&quot;y&quot;:5.827652263700825},&quot;rotate&quot;:-2.643070779108555,&quot;skewX&quot;:8.326672684688727e-16,&quot;scale&quot;:{&quot;x&quot;:0.9999999999999968,&quot;y&quot;:1.0000000000000064}},&quot;opacity&quot;:1,&quot;path&quot;:{&quot;type&quot;:&quot;ARC&quot;,&quot;size&quot;:{&quot;x&quot;:368.22244650883835,&quot;y&quot;:370.24850074172286},&quot;startAngle&quot;:1.1811312631586808,&quot;sweepAngle&quot;:0.4274550650202702,&quot;selectedObjectIds&quot;:[&quot;3c35e9ea-90c5-4097-9336-4edc9a629d73&quot;]},&quot;pathStyles&quot;:[{&quot;type&quot;:&quot;FILL&quot;,&quot;fillStyle&quot;:&quot;rgba(0,0,0,0)&quot;},{&quot;type&quot;:&quot;STROKE&quot;,&quot;strokeStyle&quot;:&quot;rgba(187,187,188,1)&quot;,&quot;lineWidth&quot;:20.7093848222138,&quot;lineJoin&quot;:&quot;round&quot;}],&quot;isLocked&quot;:false,&quot;parent&quot;:{&quot;type&quot;:&quot;CHILD&quot;,&quot;parentId&quot;:&quot;2d11619c-823a-4104-8a42-ce221ab3d5c8&quot;,&quot;order&quot;:&quot;8&quot;}},&quot;0208fb1c-a6eb-4283-a16b-6252185c53e7&quot;:{&quot;type&quot;:&quot;FIGURE_OBJECT&quot;,&quot;id&quot;:&quot;0208fb1c-a6eb-4283-a16b-6252185c53e7&quot;,&quot;relativeTransform&quot;:{&quot;translate&quot;:{&quot;x&quot;:-221.09816903169923,&quot;y&quot;:-5.626937249932137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9]}],&quot;text&quot;:&quot;Bacterial &quot;},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2]}],&quot;text&quot;:&quot;Ori&quot;,&quot;base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}],&quot;verticalAlign&quot;:&quot;TOP&quot;,&quot;_lastCaretLocation&quot;:{&quot;lineIndex&quot;:0,&quot;runIndex&quot;:-1,&quot;charIndex&quot;:-1,&quot;endOfLine&quot;:true}},&quot;size&quot;:{&quot;x&quot;:85.29250625054824,&quot;y&quot;:38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9&quot;}},&quot;a6ac3052-8839-40ae-a1c0-55d40ffaabb4&quot;:{&quot;type&quot;:&quot;FIGURE_OBJECT&quot;,&quot;id&quot;:&quot;a6ac3052-8839-40ae-a1c0-55d40ffaabb4&quot;,&quot;relativeTransform&quot;:{&quot;translate&quot;:{&quot;x&quot;:10.079754179138405,&quot;y&quot;:-2.171776307727692},&quot;rotate&quot;:-1.2640260422717846,&quot;skewX&quot;:1.9428902930940342e-15,&quot;scale&quot;:{&quot;x&quot;:0.9999999999999973,&quot;y&quot;:1.0000000000000082}},&quot;opacity&quot;:1,&quot;path&quot;:{&quot;type&quot;:&quot;ARC&quot;,&quot;size&quot;:{&quot;x&quot;:368.22244650883835,&quot;y&quot;:370.24850074172286},&quot;startAngle&quot;:1.5707963267948966,&quot;sweepAngle&quot;:0.03779000138405397,&quot;selectedObjectIds&quot;:[&quot;497b2016-4eaa-4bfa-b04d-bc6492ef24bb&quot;]},&quot;pathStyles&quot;:[{&quot;type&quot;:&quot;FILL&quot;,&quot;fillStyle&quot;:&quot;rgba(0,0,0,0)&quot;},{&quot;type&quot;:&quot;STROKE&quot;,&quot;strokeStyle&quot;:&quot;rgba(242,179,66,1)&quot;,&quot;lineWidth&quot;:20.7093848222138,&quot;lineJoin&quot;:&quot;round&quot;}],&quot;isLocked&quot;:false,&quot;parent&quot;:{&quot;type&quot;:&quot;CHILD&quot;,&quot;parentId&quot;:&quot;2d11619c-823a-4104-8a42-ce221ab3d5c8&quot;,&quot;order&quot;:&quot;95&quot;}},&quot;4b3e5bc6-f239-4e36-a67d-a0e443f84f30&quot;:{&quot;type&quot;:&quot;FIGURE_OBJECT&quot;,&quot;id&quot;:&quot;4b3e5bc6-f239-4e36-a67d-a0e443f84f30&quot;,&quot;relativeTransform&quot;:{&quot;translate&quot;:{&quot;x&quot;:220.50447820992022,&quot;y&quot;:70.89834492727712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4]}],&quot;text&quot;:&quot;attB2&quot;}],&quot;verticalAlign&quot;:&quot;TOP&quot;,&quot;_lastCaretLocation&quot;:{&quot;lineIndex&quot;:0,&quot;runIndex&quot;:0,&quot;charIndex&quot;:1}},&quot;size&quot;:{&quot;x&quot;:85.29250625054824,&quot;y&quot;:37.165367090997385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97&quot;}},&quot;bcdd7b08-2365-4f2e-a7b0-6d9c4efae4c5&quot;:{&quot;type&quot;:&quot;FIGURE_OBJECT&quot;,&quot;id&quot;:&quot;bcdd7b08-2365-4f2e-a7b0-6d9c4efae4c5&quot;,&quot;relativeTransform&quot;:{&quot;translate&quot;:{&quot;x&quot;:19.079754179138458,&quot;y&quot;:6.828223692272297},&quot;rotate&quot;:-3.1415926535897913,&quot;skewX&quot;:2.0539125955565775e-15,&quot;scale&quot;:{&quot;x&quot;:0.9999999999999947,&quot;y&quot;:1.0000000000000089}},&quot;opacity&quot;:1,&quot;path&quot;:{&quot;type&quot;:&quot;ARC&quot;,&quot;size&quot;:{&quot;x&quot;:368.22244650883835,&quot;y&quot;:370.24850074172286},&quot;startAngle&quot;:1.5707963267948966,&quot;sweepAngle&quot;:0.03779000138405397,&quot;selectedObjectIds&quot;:[&quot;497b2016-4eaa-4bfa-b04d-bc6492ef24bb&quot;]},&quot;pathStyles&quot;:[{&quot;type&quot;:&quot;FILL&quot;,&quot;fillStyle&quot;:&quot;rgba(0,0,0,0)&quot;},{&quot;type&quot;:&quot;STROKE&quot;,&quot;strokeStyle&quot;:&quot;rgba(242,179,66,1)&quot;,&quot;lineWidth&quot;:20.7093848222138,&quot;lineJoin&quot;:&quot;round&quot;}],&quot;isLocked&quot;:false,&quot;parent&quot;:{&quot;type&quot;:&quot;CHILD&quot;,&quot;parentId&quot;:&quot;2d11619c-823a-4104-8a42-ce221ab3d5c8&quot;,&quot;order&quot;:&quot;98&quot;}},&quot;c0100277-42bd-442b-93d6-937701185705&quot;:{&quot;type&quot;:&quot;FIGURE_OBJECT&quot;,&quot;id&quot;:&quot;c0100277-42bd-442b-93d6-937701185705&quot;,&quot;relativeTransform&quot;:{&quot;translate&quot;:{&quot;x&quot;:26.843478209920164,&quot;y&quot;:-188.6726550727229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4]}],&quot;text&quot;:&quot;attB4&quot;}],&quot;verticalAlign&quot;:&quot;TOP&quot;,&quot;_lastCaretLocation&quot;:{&quot;lineIndex&quot;:0,&quot;runIndex&quot;:-1,&quot;charIndex&quot;:-1,&quot;endOfLine&quot;:true}},&quot;size&quot;:{&quot;x&quot;:85.29250625054824,&quot;y&quot;:37.165367090997385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99&quot;}},&quot;b8e222cb-e881-4d5b-8baa-0be84c1fffd3&quot;:{&quot;type&quot;:&quot;FIGURE_OBJECT&quot;,&quot;id&quot;:&quot;b8e222cb-e881-4d5b-8baa-0be84c1fffd3&quot;,&quot;relativeTransform&quot;:{&quot;translate&quot;:{&quot;x&quot;:9.044738536340349,&quot;y&quot;:1.3437487480273966},&quot;rotate&quot;:0.8613844266717937,&quot;skewX&quot;:3.88578058618805e-16,&quot;scale&quot;:{&quot;x&quot;:0.9999999999999998,&quot;y&quot;:1.0000000000000002}},&quot;opacity&quot;:1,&quot;path&quot;:{&quot;type&quot;:&quot;ARC&quot;,&quot;size&quot;:{&quot;x&quot;:-368.222446508837,&quot;y&quot;:370.248500741724},&quot;startAngle&quot;:-0.5375691087840481,&quot;sweepAngle&quot;:0.2603469266118372,&quot;selectedObjectIds&quot;:[&quot;b8e222cb-e881-4d5b-8baa-0be84c1fffd3&quot;]},&quot;pathStyles&quot;:[{&quot;type&quot;:&quot;FILL&quot;,&quot;fillStyle&quot;:&quot;rgba(0,0,0,0)&quot;},{&quot;type&quot;:&quot;STROKE&quot;,&quot;strokeStyle&quot;:&quot;rgba(243,205,204,1)&quot;,&quot;lineWidth&quot;:20.70938482221373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995&quot;}},&quot;2073ab36-f226-4145-bae8-110a6af95b2f&quot;:{&quot;type&quot;:&quot;FIGURE_OBJECT&quot;,&quot;id&quot;:&quot;2073ab36-f226-4145-bae8-110a6af95b2f&quot;,&quot;relativeTransform&quot;:{&quot;translate&quot;:{&quot;x&quot;:9.044738536340297,&quot;y&quot;:1.3437487480274006},&quot;rotate&quot;:-0.3358378337096062,&quot;skewX&quot;:3.8857805861880504e-16,&quot;scale&quot;:{&quot;x&quot;:0.9999999999999997,&quot;y&quot;:1.0000000000000002}},&quot;opacity&quot;:1,&quot;path&quot;:{&quot;type&quot;:&quot;ARC&quot;,&quot;size&quot;:{&quot;x&quot;:-368.222446508837,&quot;y&quot;:370.248500741724},&quot;startAngle&quot;:-0.5375691087840481,&quot;sweepAngle&quot;:0.35338568877405585,&quot;selectedObjectIds&quot;:[&quot;2073ab36-f226-4145-bae8-110a6af95b2f&quot;]},&quot;pathStyles&quot;:[{&quot;type&quot;:&quot;FILL&quot;,&quot;fillStyle&quot;:&quot;rgba(0,0,0,0)&quot;},{&quot;type&quot;:&quot;STROKE&quot;,&quot;strokeStyle&quot;:&quot;rgba(6,148,142,1)&quot;,&quot;lineWidth&quot;:20.70938482221373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997&quot;}},&quot;993332db-6423-416d-98e7-4447069b1cc0&quot;:{&quot;type&quot;:&quot;FIGURE_OBJECT&quot;,&quot;id&quot;:&quot;993332db-6423-416d-98e7-4447069b1cc0&quot;,&quot;relativeTransform&quot;:{&quot;translate&quot;:{&quot;x&quot;:8.1198970362813,&quot;y&quot;:0.8276522637007706},&quot;rotate&quot;:-0.9635107879608393,&quot;skewX&quot;:5.5511151231258e-16,&quot;scale&quot;:{&quot;x&quot;:0.9999999999999984,&quot;y&quot;:1.0000000000000042}},&quot;opacity&quot;:1,&quot;path&quot;:{&quot;type&quot;:&quot;ARC&quot;,&quot;size&quot;:{&quot;x&quot;:368.22244650883835,&quot;y&quot;:370.24850074172286},&quot;startAngle&quot;:1.3218378441210106,&quot;sweepAngle&quot;:0.28674848405793996},&quot;pathStyles&quot;:[{&quot;type&quot;:&quot;FILL&quot;,&quot;fillStyle&quot;:&quot;transparent&quot;},{&quot;type&quot;:&quot;STROKE&quot;,&quot;strokeStyle&quot;:&quot;rgba(221,241,245,1)&quot;,&quot;lineWidth&quot;:20.7093848222138,&quot;lineJoin&quot;:&quot;round&quot;}],&quot;isLocked&quot;:false,&quot;parent&quot;:{&quot;type&quot;:&quot;CHILD&quot;,&quot;parentId&quot;:&quot;2d11619c-823a-4104-8a42-ce221ab3d5c8&quot;,&quot;order&quot;:&quot;998&quot;}},&quot;5d39b202-a04e-43a5-8cdc-413e04348a9f&quot;:{&quot;type&quot;:&quot;FIGURE_OBJECT&quot;,&quot;id&quot;:&quot;5d39b202-a04e-43a5-8cdc-413e04348a9f&quot;,&quot;relativeTransform&quot;:{&quot;translate&quot;:{&quot;x&quot;:220.5048309683008,&quot;y&quot;:104.37306275006786},&quot;rotate&quot;:0,&quot;skewX&quot;:0,&quot;scale&quot;:{&quot;x&quot;:1,&quot;y&quot;:1}},&quot;opacity&quot;:1,&quot;pathStyles&quot;:[{&quot;type&quot;:&quot;FILL&quot;,&quot;fillStyle&quot;:&quot;rgba(23,23,23,1)&quot;}],&quot;text&quot;:{&quot;textData&quot;:{&quot;lineSpacing&quot;:&quot;normal&quot;,&quot;alignment&quot;:&quot;center&quot;,&quot;lines&quot;:[{&quot;runs&quot;:[{&quot;style&quot;:{&quot;fontFamily&quot;:&quot;Roboto&quot;,&quot;fontSize&quot;:16.314337991201974,&quot;color&quot;:&quot;rgba(23,23,23,1)&quot;,&quot;fontWeight&quot;:&quot;normal&quot;,&quot;fontStyle&quot;:&quot;normal&quot;,&quot;decoration&quot;:&quot;none&quot;,&quot;script&quot;:&quot;none&quot;},&quot;range&quot;:[0,19]}],&quot;text&quot;:&quot;SV40 poly (A) signal&quot;}],&quot;verticalAlign&quot;:&quot;TOP&quot;,&quot;_lastCaretLocation&quot;:{&quot;lineIndex&quot;:0,&quot;runIndex&quot;:-1,&quot;charIndex&quot;:-1,&quot;endOfLine&quot;:true}},&quot;size&quot;:{&quot;x&quot;:85.29250625054824,&quot;y&quot;:38},&quot;targetSize&quot;:{&quot;x&quot;:79.60633916717836,&quot;y&quot;:37.165367090997385},&quot;format&quot;:&quot;BETTER_TEXT&quot;,&quot;verticalAlign&quot;:&quot;TOP&quot;},&quot;isLocked&quot;:false,&quot;parent&quot;:{&quot;type&quot;:&quot;CHILD&quot;,&quot;parentId&quot;:&quot;2d11619c-823a-4104-8a42-ce221ab3d5c8&quot;,&quot;order&quot;:&quot;99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bcdd7b08-2365-4f2e-a7b0-6d9c4efae4c5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bcdd7b08-2365-4f2e-a7b0-6d9c4efae4c5&quot;:{&quot;type&quot;:&quot;FIGURE_OBJECT&quot;,&quot;id&quot;:&quot;bcdd7b08-2365-4f2e-a7b0-6d9c4efae4c5&quot;,&quot;relativeTransform&quot;:{&quot;translate&quot;:{&quot;x&quot;:19.079754179138458,&quot;y&quot;:6.828223692272297},&quot;rotate&quot;:-3.1415926535897913,&quot;skewX&quot;:2.0539125955565775e-15,&quot;scale&quot;:{&quot;x&quot;:0.9999999999999947,&quot;y&quot;:1.0000000000000089}},&quot;opacity&quot;:1,&quot;path&quot;:{&quot;type&quot;:&quot;ARC&quot;,&quot;size&quot;:{&quot;x&quot;:368.22244650883835,&quot;y&quot;:370.24850074172286},&quot;startAngle&quot;:1.5707963267948966,&quot;sweepAngle&quot;:0.03779000138405397,&quot;selectedObjectIds&quot;:[&quot;497b2016-4eaa-4bfa-b04d-bc6492ef24bb&quot;]},&quot;pathStyles&quot;:[{&quot;type&quot;:&quot;FILL&quot;,&quot;fillStyle&quot;:&quot;rgba(0,0,0,0)&quot;},{&quot;type&quot;:&quot;STROKE&quot;,&quot;strokeStyle&quot;:&quot;rgba(242,179,66,1)&quot;,&quot;lineWidth&quot;:20.7093848222138,&quot;lineJoin&quot;:&quot;round&quot;}],&quot;isLocked&quot;:false,&quot;parent&quot;:{&quot;type&quot;:&quot;CHILD&quot;,&quot;parentId&quot;:&quot;2d11619c-823a-4104-8a42-ce221ab3d5c8&quot;,&quot;order&quot;:&quot;98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b8e222cb-e881-4d5b-8baa-0be84c1fffd3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b8e222cb-e881-4d5b-8baa-0be84c1fffd3&quot;:{&quot;type&quot;:&quot;FIGURE_OBJECT&quot;,&quot;id&quot;:&quot;b8e222cb-e881-4d5b-8baa-0be84c1fffd3&quot;,&quot;relativeTransform&quot;:{&quot;translate&quot;:{&quot;x&quot;:9.044738536340349,&quot;y&quot;:1.3437487480273966},&quot;rotate&quot;:0.8613844266717937,&quot;skewX&quot;:3.88578058618805e-16,&quot;scale&quot;:{&quot;x&quot;:0.9999999999999998,&quot;y&quot;:1.0000000000000002}},&quot;opacity&quot;:1,&quot;path&quot;:{&quot;type&quot;:&quot;ARC&quot;,&quot;size&quot;:{&quot;x&quot;:-368.222446508837,&quot;y&quot;:370.248500741724},&quot;startAngle&quot;:-0.5375691087840481,&quot;sweepAngle&quot;:0.2603469266118372,&quot;selectedObjectIds&quot;:[&quot;b8e222cb-e881-4d5b-8baa-0be84c1fffd3&quot;]},&quot;pathStyles&quot;:[{&quot;type&quot;:&quot;FILL&quot;,&quot;fillStyle&quot;:&quot;rgba(0,0,0,0)&quot;},{&quot;type&quot;:&quot;STROKE&quot;,&quot;strokeStyle&quot;:&quot;rgba(243,205,204,1)&quot;,&quot;lineWidth&quot;:20.70938482221373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995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2073ab36-f226-4145-bae8-110a6af95b2f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2073ab36-f226-4145-bae8-110a6af95b2f&quot;:{&quot;type&quot;:&quot;FIGURE_OBJECT&quot;,&quot;id&quot;:&quot;2073ab36-f226-4145-bae8-110a6af95b2f&quot;,&quot;relativeTransform&quot;:{&quot;translate&quot;:{&quot;x&quot;:9.044738536340297,&quot;y&quot;:1.3437487480274006},&quot;rotate&quot;:-0.3358378337096062,&quot;skewX&quot;:3.8857805861880504e-16,&quot;scale&quot;:{&quot;x&quot;:0.9999999999999997,&quot;y&quot;:1.0000000000000002}},&quot;opacity&quot;:1,&quot;path&quot;:{&quot;type&quot;:&quot;ARC&quot;,&quot;size&quot;:{&quot;x&quot;:-368.222446508837,&quot;y&quot;:370.248500741724},&quot;startAngle&quot;:-0.5375691087840481,&quot;sweepAngle&quot;:0.35338568877405585,&quot;selectedObjectIds&quot;:[&quot;2073ab36-f226-4145-bae8-110a6af95b2f&quot;]},&quot;pathStyles&quot;:[{&quot;type&quot;:&quot;FILL&quot;,&quot;fillStyle&quot;:&quot;rgba(0,0,0,0)&quot;},{&quot;type&quot;:&quot;STROKE&quot;,&quot;strokeStyle&quot;:&quot;rgba(6,148,142,1)&quot;,&quot;lineWidth&quot;:20.70938482221373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997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993332db-6423-416d-98e7-4447069b1cc0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993332db-6423-416d-98e7-4447069b1cc0&quot;:{&quot;type&quot;:&quot;FIGURE_OBJECT&quot;,&quot;id&quot;:&quot;993332db-6423-416d-98e7-4447069b1cc0&quot;,&quot;relativeTransform&quot;:{&quot;translate&quot;:{&quot;x&quot;:8.1198970362813,&quot;y&quot;:0.8276522637007706},&quot;rotate&quot;:-0.9635107879608393,&quot;skewX&quot;:5.5511151231258e-16,&quot;scale&quot;:{&quot;x&quot;:0.9999999999999984,&quot;y&quot;:1.0000000000000042}},&quot;opacity&quot;:1,&quot;path&quot;:{&quot;type&quot;:&quot;ARC&quot;,&quot;size&quot;:{&quot;x&quot;:368.22244650883835,&quot;y&quot;:370.24850074172286},&quot;startAngle&quot;:1.3218378441210106,&quot;sweepAngle&quot;:0.28674848405793996},&quot;pathStyles&quot;:[{&quot;type&quot;:&quot;FILL&quot;,&quot;fillStyle&quot;:&quot;transparent&quot;},{&quot;type&quot;:&quot;STROKE&quot;,&quot;strokeStyle&quot;:&quot;rgba(221,241,245,1)&quot;,&quot;lineWidth&quot;:20.7093848222138,&quot;lineJoin&quot;:&quot;round&quot;}],&quot;isLocked&quot;:false,&quot;parent&quot;:{&quot;type&quot;:&quot;CHILD&quot;,&quot;parentId&quot;:&quot;2d11619c-823a-4104-8a42-ce221ab3d5c8&quot;,&quot;order&quot;:&quot;998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a4dd9b9c-51fc-4392-ba67-afb0526a957e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a4dd9b9c-51fc-4392-ba67-afb0526a957e&quot;:{&quot;type&quot;:&quot;FIGURE_OBJECT&quot;,&quot;id&quot;:&quot;a4dd9b9c-51fc-4392-ba67-afb0526a957e&quot;,&quot;relativeTransform&quot;:{&quot;translate&quot;:{&quot;x&quot;:9.402887282173765,&quot;y&quot;:3.5400783728621352},&quot;rotate&quot;:-3.027313591028833,&quot;skewX&quot;:2.775557561562899e-17,&quot;scale&quot;:{&quot;x&quot;:0.9999999999999987,&quot;y&quot;:1}},&quot;opacity&quot;:1,&quot;path&quot;:{&quot;type&quot;:&quot;ELLIPSE&quot;,&quot;size&quot;:{&quot;x&quot;:372.772384672125,&quot;y&quot;:368.63098103450176}},&quot;pathStyles&quot;:[{&quot;type&quot;:&quot;FILL&quot;,&quot;fillStyle&quot;:&quot;transparent&quot;},{&quot;type&quot;:&quot;STROKE&quot;,&quot;strokeStyle&quot;:&quot;rgba(160,160,160,1)&quot;,&quot;lineWidth&quot;:4.14187696444276,&quot;lineJoin&quot;:&quot;round&quot;}],&quot;isLocked&quot;:false,&quot;parent&quot;:{&quot;type&quot;:&quot;CHILD&quot;,&quot;parentId&quot;:&quot;2d11619c-823a-4104-8a42-ce221ab3d5c8&quot;,&quot;order&quot;:&quot;02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3959677e-9b59-4bcb-bdea-f67a04126903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3959677e-9b59-4bcb-bdea-f67a04126903&quot;:{&quot;type&quot;:&quot;FIGURE_OBJECT&quot;,&quot;id&quot;:&quot;3959677e-9b59-4bcb-bdea-f67a04126903&quot;,&quot;relativeTransform&quot;:{&quot;translate&quot;:{&quot;x&quot;:9.119897036281104,&quot;y&quot;:5.827652263700765},&quot;rotate&quot;:-1.395476572154996,&quot;skewX&quot;:6.106226635438382e-16,&quot;scale&quot;:{&quot;x&quot;:0.9999999999999983,&quot;y&quot;:1.0000000000000018}},&quot;opacity&quot;:1,&quot;path&quot;:{&quot;type&quot;:&quot;ARC&quot;,&quot;size&quot;:{&quot;x&quot;:368.22244650883835,&quot;y&quot;:370.24850074172286},&quot;startAngle&quot;:1.3218378441210106,&quot;sweepAngle&quot;:0.28674848405793996},&quot;pathStyles&quot;:[{&quot;type&quot;:&quot;FILL&quot;,&quot;fillStyle&quot;:&quot;transparent&quot;},{&quot;type&quot;:&quot;STROKE&quot;,&quot;strokeStyle&quot;:&quot;rgb(187, 187, 188)&quot;,&quot;lineWidth&quot;:20.7093848222138,&quot;lineJoin&quot;:&quot;round&quot;}],&quot;isLocked&quot;:false,&quot;parent&quot;:{&quot;type&quot;:&quot;CHILD&quot;,&quot;parentId&quot;:&quot;2d11619c-823a-4104-8a42-ce221ab3d5c8&quot;,&quot;order&quot;:&quot;05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bfe4d7b9-94b1-4a0a-878d-5b40ea996994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bfe4d7b9-94b1-4a0a-878d-5b40ea996994&quot;:{&quot;type&quot;:&quot;FIGURE_OBJECT&quot;,&quot;id&quot;:&quot;bfe4d7b9-94b1-4a0a-878d-5b40ea996994&quot;,&quot;relativeTransform&quot;:{&quot;translate&quot;:{&quot;x&quot;:9.044738536339935,&quot;y&quot;:1.3437487480274726},&quot;rotate&quot;:0.10371817069197634,&quot;skewX&quot;:2.359223927328458e-16,&quot;scale&quot;:{&quot;x&quot;:0.9999999999999999,&quot;y&quot;:1}},&quot;opacity&quot;:1,&quot;path&quot;:{&quot;type&quot;:&quot;ARC&quot;,&quot;size&quot;:{&quot;x&quot;:-368.22244650883727,&quot;y&quot;:370.24850074172355},&quot;startAngle&quot;:-1.011823141890489,&quot;sweepAngle&quot;:0.7346009597182785,&quot;selectedObjectIds&quot;:[&quot;62b788f0-6e5e-4305-8250-e6a00a392386&quot;]},&quot;pathStyles&quot;:[{&quot;type&quot;:&quot;FILL&quot;,&quot;fillStyle&quot;:&quot;rgba(0,0,0,0)&quot;},{&quot;type&quot;:&quot;STROKE&quot;,&quot;strokeStyle&quot;:&quot;rgb(57, 201, 0)&quot;,&quot;lineWidth&quot;:20.70938482221375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1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fff3ae6c-3715-410a-8953-183722223959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fff3ae6c-3715-410a-8953-183722223959&quot;:{&quot;type&quot;:&quot;FIGURE_OBJECT&quot;,&quot;id&quot;:&quot;fff3ae6c-3715-410a-8953-183722223959&quot;,&quot;relativeTransform&quot;:{&quot;translate&quot;:{&quot;x&quot;:8.809915832517655,&quot;y&quot;:3.5787805784530278},&quot;rotate&quot;:3.0220048013693326,&quot;skewX&quot;:-3.1918911957973324e-16,&quot;scale&quot;:{&quot;x&quot;:0.9999999999999988,&quot;y&quot;:1.0000000000000004}},&quot;opacity&quot;:1,&quot;path&quot;:{&quot;type&quot;:&quot;ARC&quot;,&quot;size&quot;:{&quot;x&quot;:368.2224465088382,&quot;y&quot;:370.2485007417228},&quot;startAngle&quot;:2.244957916149851,&quot;sweepAngle&quot;:0.42852270390369274,&quot;selectedObjectIds&quot;:[&quot;17ff5de1-2446-41ea-8fef-13f788b89690&quot;]},&quot;pathStyles&quot;:[{&quot;type&quot;:&quot;FILL&quot;,&quot;fillStyle&quot;:&quot;rgba(0,0,0,0)&quot;},{&quot;type&quot;:&quot;STROKE&quot;,&quot;strokeStyle&quot;:&quot;rgba(168,88,150,1)&quot;,&quot;lineWidth&quot;:20.709384822213796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5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f499de73-cfb7-4cb7-bad8-4765023cc7b3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f499de73-cfb7-4cb7-bad8-4765023cc7b3&quot;:{&quot;type&quot;:&quot;FIGURE_OBJECT&quot;,&quot;id&quot;:&quot;f499de73-cfb7-4cb7-bad8-4765023cc7b3&quot;,&quot;relativeTransform&quot;:{&quot;translate&quot;:{&quot;x&quot;:14.320413656486734,&quot;y&quot;:11.566031506549923},&quot;rotate&quot;:-0.5107524405069679,&quot;skewX&quot;:-5.5511151231257975e-16,&quot;scale&quot;:{&quot;x&quot;:0.9999999999999987,&quot;y&quot;:1.0000000000000016}},&quot;opacity&quot;:1,&quot;path&quot;:{&quot;type&quot;:&quot;ARC&quot;,&quot;size&quot;:{&quot;x&quot;:368.22244650883835,&quot;y&quot;:370.24850074172286},&quot;startAngle&quot;:-0.142227607492806,&quot;sweepAngle&quot;:0.14222760749280638,&quot;selectedObjectIds&quot;:[&quot;45050643-6f10-4231-a719-8b5f434b9633&quot;]},&quot;pathStyles&quot;:[{&quot;type&quot;:&quot;FILL&quot;,&quot;fillStyle&quot;:&quot;rgba(0,0,0,0)&quot;},{&quot;type&quot;:&quot;STROKE&quot;,&quot;strokeStyle&quot;:&quot;rgb(221, 176, 236)&quot;,&quot;lineWidth&quot;:20.7093848222138,&quot;lineJoin&quot;:&quot;round&quot;}],&quot;isLocked&quot;:false,&quot;parent&quot;:{&quot;type&quot;:&quot;CHILD&quot;,&quot;parentId&quot;:&quot;2d11619c-823a-4104-8a42-ce221ab3d5c8&quot;,&quot;order&quot;:&quot;7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4a4f5527-4576-4146-ad12-fe66fae898a8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4a4f5527-4576-4146-ad12-fe66fae898a8&quot;:{&quot;type&quot;:&quot;FIGURE_OBJECT&quot;,&quot;id&quot;:&quot;4a4f5527-4576-4146-ad12-fe66fae898a8&quot;,&quot;relativeTransform&quot;:{&quot;translate&quot;:{&quot;x&quot;:10.085575575974623,&quot;y&quot;:3.9041381323288578},&quot;rotate&quot;:0.5515993360694178,&quot;skewX&quot;:-3.3306690738754844e-16,&quot;scale&quot;:{&quot;x&quot;:0.9999999999999978,&quot;y&quot;:1.0000000000000022}},&quot;opacity&quot;:1,&quot;path&quot;:{&quot;type&quot;:&quot;ARC&quot;,&quot;size&quot;:{&quot;x&quot;:368.2224465088381,&quot;y&quot;:370.24850074172286},&quot;startAngle&quot;:-1.011823141890489,&quot;sweepAngle&quot;:0.4046694364445518,&quot;selectedObjectIds&quot;:[&quot;3fb8d86a-7a97-43a5-8e88-00516e822c20&quot;]},&quot;pathStyles&quot;:[{&quot;type&quot;:&quot;FILL&quot;,&quot;fillStyle&quot;:&quot;rgba(0,0,0,0)&quot;},{&quot;type&quot;:&quot;STROKE&quot;,&quot;strokeStyle&quot;:&quot;rgba(49,126,194,1)&quot;,&quot;lineWidth&quot;:20.7093848222138,&quot;lineJoin&quot;:&quot;round&quot;}],&quot;pathMarkers&quot;:{&quot;markerEnd&quot;:{&quot;type&quot;:&quot;PATH&quot;,&quot;units&quot;:{&quot;type&quot;:&quot;STROKE_WIDTH&quot;,&quot;scale&quot;:0.3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2d11619c-823a-4104-8a42-ce221ab3d5c8&quot;,&quot;order&quot;:&quot;75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3c35e9ea-90c5-4097-9336-4edc9a629d73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3c35e9ea-90c5-4097-9336-4edc9a629d73&quot;:{&quot;type&quot;:&quot;FIGURE_OBJECT&quot;,&quot;id&quot;:&quot;3c35e9ea-90c5-4097-9336-4edc9a629d73&quot;,&quot;relativeTransform&quot;:{&quot;translate&quot;:{&quot;x&quot;:11.119897036281188,&quot;y&quot;:5.827652263700825},&quot;rotate&quot;:-2.643070779108555,&quot;skewX&quot;:8.326672684688727e-16,&quot;scale&quot;:{&quot;x&quot;:0.9999999999999968,&quot;y&quot;:1.0000000000000064}},&quot;opacity&quot;:1,&quot;path&quot;:{&quot;type&quot;:&quot;ARC&quot;,&quot;size&quot;:{&quot;x&quot;:368.22244650883835,&quot;y&quot;:370.24850074172286},&quot;startAngle&quot;:1.1811312631586808,&quot;sweepAngle&quot;:0.4274550650202702,&quot;selectedObjectIds&quot;:[&quot;3c35e9ea-90c5-4097-9336-4edc9a629d73&quot;]},&quot;pathStyles&quot;:[{&quot;type&quot;:&quot;FILL&quot;,&quot;fillStyle&quot;:&quot;rgba(0,0,0,0)&quot;},{&quot;type&quot;:&quot;STROKE&quot;,&quot;strokeStyle&quot;:&quot;rgba(187,187,188,1)&quot;,&quot;lineWidth&quot;:20.7093848222138,&quot;lineJoin&quot;:&quot;round&quot;}],&quot;isLocked&quot;:false,&quot;parent&quot;:{&quot;type&quot;:&quot;CHILD&quot;,&quot;parentId&quot;:&quot;2d11619c-823a-4104-8a42-ce221ab3d5c8&quot;,&quot;order&quot;:&quot;8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ags/tag1-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515d7eaa43ca9915e304394"/>
  <p:tag name="FIGURESLIDEID" val="2d11619c-823a-4104-8a42-ce221ab3d5c8"/>
  <p:tag name="SELECTIONIDS" val="a6ac3052-8839-40ae-a1c0-55d40ffaabb4"/>
  <p:tag name="TRANSPARENTBACKGROUND" val="true"/>
  <p:tag name="VERSION" val="1765895490396"/>
  <p:tag name="TITLE" val="mCherry file"/>
  <p:tag name="CREATORNAME" val="James Morris"/>
  <p:tag name="DATEINSERTED" val="1765895490827"/>
  <p:tag name="DPI" val="300"/>
  <p:tag name="BIOJSON" val="{&quot;id&quot;:&quot;c7ab8018-2e66-4217-9da9-507edb8fd882&quot;,&quot;objects&quot;:{&quot;a6ac3052-8839-40ae-a1c0-55d40ffaabb4&quot;:{&quot;type&quot;:&quot;FIGURE_OBJECT&quot;,&quot;id&quot;:&quot;a6ac3052-8839-40ae-a1c0-55d40ffaabb4&quot;,&quot;relativeTransform&quot;:{&quot;translate&quot;:{&quot;x&quot;:10.079754179138405,&quot;y&quot;:-2.171776307727692},&quot;rotate&quot;:-1.2640260422717846,&quot;skewX&quot;:1.9428902930940342e-15,&quot;scale&quot;:{&quot;x&quot;:0.9999999999999973,&quot;y&quot;:1.0000000000000082}},&quot;opacity&quot;:1,&quot;path&quot;:{&quot;type&quot;:&quot;ARC&quot;,&quot;size&quot;:{&quot;x&quot;:368.22244650883835,&quot;y&quot;:370.24850074172286},&quot;startAngle&quot;:1.5707963267948966,&quot;sweepAngle&quot;:0.03779000138405397,&quot;selectedObjectIds&quot;:[&quot;497b2016-4eaa-4bfa-b04d-bc6492ef24bb&quot;]},&quot;pathStyles&quot;:[{&quot;type&quot;:&quot;FILL&quot;,&quot;fillStyle&quot;:&quot;rgba(0,0,0,0)&quot;},{&quot;type&quot;:&quot;STROKE&quot;,&quot;strokeStyle&quot;:&quot;rgba(242,179,66,1)&quot;,&quot;lineWidth&quot;:20.7093848222138,&quot;lineJoin&quot;:&quot;round&quot;}],&quot;isLocked&quot;:false,&quot;parent&quot;:{&quot;type&quot;:&quot;CHILD&quot;,&quot;parentId&quot;:&quot;2d11619c-823a-4104-8a42-ce221ab3d5c8&quot;,&quot;order&quot;:&quot;95&quot;}},&quot;2d11619c-823a-4104-8a42-ce221ab3d5c8&quot;:{&quot;id&quot;:&quot;2d11619c-823a-4104-8a42-ce221ab3d5c8&quot;,&quot;type&quot;:&quot;FIGURE_OBJECT&quot;,&quot;document&quot;:{&quot;type&quot;:&quot;FIGURE&quot;,&quot;canvasType&quot;:&quot;FIGURE&quot;,&quot;units&quot;:&quot;in&quot;,&quot;aspectRatio&quot;:0,&quot;title&quot;:&quot;&quot;},&quot;parent&quot;:{&quot;type&quot;:&quot;DOCUMENT&quot;,&quot;parentId&quot;:&quot;c7ab8018-2e66-4217-9da9-507edb8fd882&quot;,&quot;order&quot;:&quot;9&quot;}},&quot;c7ab8018-2e66-4217-9da9-507edb8fd882&quot;:{&quot;id&quot;:&quot;c7ab8018-2e66-4217-9da9-507edb8fd882&quot;,&quot;type&quot;:&quot;FIGURE_OBJECT&quot;,&quot;document&quot;:{&quot;type&quot;:&quot;DOCUMENT_GROUP&quot;,&quot;canvasType&quot;:&quot;SLIDE&quot;,&quot;units&quot;:&quot;in&quot;}}}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On-screen Show (16:9)</PresentationFormat>
  <Paragraphs>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Slide 1</vt:lpstr>
      <vt:lpstr>Slide 2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PptxGenJS</cp:lastModifiedBy>
  <cp:revision>1</cp:revision>
  <dcterms:created xsi:type="dcterms:W3CDTF">2025-12-16T14:31:31Z</dcterms:created>
  <dcterms:modified xsi:type="dcterms:W3CDTF">2025-12-16T14:31:31Z</dcterms:modified>
</cp:coreProperties>
</file>